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0" r:id="rId2"/>
    <p:sldId id="271" r:id="rId3"/>
    <p:sldId id="268" r:id="rId4"/>
    <p:sldId id="26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65" autoAdjust="0"/>
    <p:restoredTop sz="94653"/>
  </p:normalViewPr>
  <p:slideViewPr>
    <p:cSldViewPr snapToGrid="0">
      <p:cViewPr varScale="1">
        <p:scale>
          <a:sx n="78" d="100"/>
          <a:sy n="78" d="100"/>
        </p:scale>
        <p:origin x="73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E09B59-E799-4A53-A9A7-FC9D4C39F06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508993-E285-41E1-9959-418ACB7061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267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947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8748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3253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</a:t>
            </a:r>
            <a:r>
              <a:rPr lang="en-US"/>
              <a:t>indicated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594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27A766-17BA-4D76-BEF3-CF7B5641D1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D199C5-9EB4-435F-93A4-CA0FB28ECC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C00DF-6F7A-4BED-AF70-E9B14BE3A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336244-1B73-42ED-8EF7-F26140B28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FBFD8E-7596-43B5-A041-66CD0E1F0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359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90D77-6E40-4C7C-BFA7-5F8102761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22AB8C-66B8-4DA4-92E1-06DFFB5EC8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3B7507-5825-40AF-A6D6-2CF853429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49A5B-D3D9-47C7-8170-A28B32F5C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96C180-35E9-4899-A853-96F45D413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B7343E-0202-4F00-AC68-F09667BC2F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D59F68-717F-4913-B6CD-577915D27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DCF45-CD3D-4CD9-98A3-0D10E0FA3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C6470C-B2A2-41E2-B9C0-5E5DA3232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9B5810-FC13-4C73-99FA-D8095136D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155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D8272-7261-4262-A75F-BF338CDA63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CBD7F5-32FD-43BA-A532-C668D40024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25A976-B415-4FA3-92E3-6A779E6FC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F6217-890A-4EBB-BE1B-242258F6C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3A75D-0743-4FC7-AF73-7EBF8D0EB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65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57C26-6C97-4BDD-88CB-9C16F2A13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29E43D-3384-46D4-8511-C602E4AC20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995AB5-014C-41D4-ABDB-ED4D72792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2CD61-291E-4B9C-8DC6-AB38E2002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70F77-F10C-414C-9A26-4F961D399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229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F9289-AAA1-4A3C-8363-8A8A6B9B5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61322D-B163-4C03-B767-07C4AD9678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84C6B8-70C2-487C-B3D0-E4B9A77E03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B4C3CF-4A77-4302-B883-B7A140DC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96E5EC-847F-46E7-976D-D90FC336F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52731D-74E8-49C4-9412-691328C4D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767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FF5E9-7009-46DE-8968-F0963E0839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EA9F00-528B-49DC-BCC6-89F6B3AB4F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EB2E1A-41CA-4483-B59B-E30B9C963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6A40BE-3F36-4D4F-9411-497F72A8DF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B961AF-E66B-402A-A302-ED0E3EE1B1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D20681-89D5-4BC3-B897-C2A00E4D5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57FD78-4BCC-4374-9EEF-D7D291200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EF6232-6DC5-4883-A124-10D550A76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468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93925-2AEB-4867-928C-C6F6A2314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CD4CEA-451A-42A8-84CB-89EC28276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1D512B-D6D8-436D-AB51-7BE43CF08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5C8DA5-60D3-4E07-A7DB-BEA73DE14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865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7C80CC-F60E-4F96-975A-B7C2D8926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8A23FF-6E1C-4E91-8A40-C81549BCD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5A824D-1A5C-4EED-A096-1592A04AA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736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A8565-D0D1-44B8-AFED-76DE1717B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CF6B1B-7BDB-4248-AC41-5C26740342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D16E3C-E431-400F-9E59-69852919F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F9FB58-6ACD-4B7C-BBA1-219019236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87A048-3765-4393-B850-E23B2E3D6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E608EE-D373-433E-A5B8-3DD7E14D8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14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895DB-00CD-4AB8-810C-BB75CF5EED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0E2184-B211-44CB-87AF-78FCFD2C2D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6E0CD1-E92F-4891-AC39-5097F49DCA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2A5683-C573-4C1E-A0AC-A9E986BE7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BBD0BC-4F73-477A-841A-8E467E92E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FA612-E0FC-42B6-9B28-7922862BD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89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42D917-29A4-4ACE-B218-2DD537E840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CF55AA-F196-4E78-B923-3235CE9FA3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E1ABC-F944-461C-854A-78532ACB70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6AB73-4110-4733-A9F2-A4A44B8FD0A5}" type="datetimeFigureOut">
              <a:rPr lang="en-US" smtClean="0"/>
              <a:t>12/1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A88061-A0B4-402C-9C71-218B4450EE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D5D7DD-3FA2-4ECB-8FD5-94CB49554D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656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50D0636-3683-924D-B5B8-FF29F58519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984071"/>
              </p:ext>
            </p:extLst>
          </p:nvPr>
        </p:nvGraphicFramePr>
        <p:xfrm>
          <a:off x="4639734" y="235975"/>
          <a:ext cx="3963492" cy="644013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06396">
                  <a:extLst>
                    <a:ext uri="{9D8B030D-6E8A-4147-A177-3AD203B41FA5}">
                      <a16:colId xmlns:a16="http://schemas.microsoft.com/office/drawing/2014/main" val="3090775154"/>
                    </a:ext>
                  </a:extLst>
                </a:gridCol>
                <a:gridCol w="979433">
                  <a:extLst>
                    <a:ext uri="{9D8B030D-6E8A-4147-A177-3AD203B41FA5}">
                      <a16:colId xmlns:a16="http://schemas.microsoft.com/office/drawing/2014/main" val="4284154881"/>
                    </a:ext>
                  </a:extLst>
                </a:gridCol>
                <a:gridCol w="888744">
                  <a:extLst>
                    <a:ext uri="{9D8B030D-6E8A-4147-A177-3AD203B41FA5}">
                      <a16:colId xmlns:a16="http://schemas.microsoft.com/office/drawing/2014/main" val="3389466972"/>
                    </a:ext>
                  </a:extLst>
                </a:gridCol>
                <a:gridCol w="988919">
                  <a:extLst>
                    <a:ext uri="{9D8B030D-6E8A-4147-A177-3AD203B41FA5}">
                      <a16:colId xmlns:a16="http://schemas.microsoft.com/office/drawing/2014/main" val="2279340466"/>
                    </a:ext>
                  </a:extLst>
                </a:gridCol>
              </a:tblGrid>
              <a:tr h="214671"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Table 2 Details of cardiac related events due to Ocrelizumab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8766217"/>
                  </a:ext>
                </a:extLst>
              </a:tr>
              <a:tr h="3373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Atrial Fibrillation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Cardiac Failur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Coronary Artery Diseas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438089380"/>
                  </a:ext>
                </a:extLst>
              </a:tr>
              <a:tr h="46767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Total number of reported AE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48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3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920175772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Sex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534598961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Female 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9 (47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8 (58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1 (39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841124569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Mal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9 (47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6 (33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7 (51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663910971"/>
                  </a:ext>
                </a:extLst>
              </a:tr>
              <a:tr h="2760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  Not Specified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4 (8.3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 (9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432994717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Age in year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661866705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8-6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4 (3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7 (56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1 (62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460179651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65-8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 (30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2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1 (8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264713429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Not Specified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4 (3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5 (31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8 (29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09545773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Type of Reaction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792991182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Seriou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9 (97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8 (10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9 (99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748225654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Nonseriou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2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0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849307407"/>
                  </a:ext>
                </a:extLst>
              </a:tr>
              <a:tr h="35267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Outcome reported per AE 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7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795982903"/>
                  </a:ext>
                </a:extLst>
              </a:tr>
              <a:tr h="35267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Hospitalization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1 (40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3 (35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6 (37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1464695572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Life-Threatening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3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4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4 (8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4221329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Nonseriou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0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841322947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Death 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7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7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6 (9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590993590"/>
                  </a:ext>
                </a:extLst>
              </a:tr>
              <a:tr h="2376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Other Outcom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4 (46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4 (52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6 (43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039908235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Disabled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0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379382017"/>
                  </a:ext>
                </a:extLst>
              </a:tr>
              <a:tr h="3526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 Congenital Anomaly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0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1511104207"/>
                  </a:ext>
                </a:extLst>
              </a:tr>
              <a:tr h="46767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Outcome counts by year received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 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631231304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1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407246053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1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907864054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1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4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870501083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1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1 (21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9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5 (14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310808397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1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15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 (30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5 (25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284599143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2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5 (28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2 (33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4 (30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3477672007"/>
                  </a:ext>
                </a:extLst>
              </a:tr>
              <a:tr h="1303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2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5 (28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4 (21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43 (24.5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85" marR="3885" marT="3885" marB="0" anchor="ctr"/>
                </a:tc>
                <a:extLst>
                  <a:ext uri="{0D108BD9-81ED-4DB2-BD59-A6C34878D82A}">
                    <a16:rowId xmlns:a16="http://schemas.microsoft.com/office/drawing/2014/main" val="2671759659"/>
                  </a:ext>
                </a:extLst>
              </a:tr>
            </a:tbl>
          </a:graphicData>
        </a:graphic>
      </p:graphicFrame>
      <p:sp>
        <p:nvSpPr>
          <p:cNvPr id="3" name="TextBox 1">
            <a:extLst>
              <a:ext uri="{FF2B5EF4-FFF2-40B4-BE49-F238E27FC236}">
                <a16:creationId xmlns:a16="http://schemas.microsoft.com/office/drawing/2014/main" id="{A50BDAEB-0576-41EA-B780-A6DB8D0F8614}"/>
              </a:ext>
            </a:extLst>
          </p:cNvPr>
          <p:cNvSpPr txBox="1"/>
          <p:nvPr/>
        </p:nvSpPr>
        <p:spPr>
          <a:xfrm>
            <a:off x="409322" y="23597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1.</a:t>
            </a:r>
          </a:p>
        </p:txBody>
      </p:sp>
    </p:spTree>
    <p:extLst>
      <p:ext uri="{BB962C8B-B14F-4D97-AF65-F5344CB8AC3E}">
        <p14:creationId xmlns:p14="http://schemas.microsoft.com/office/powerpoint/2010/main" val="2038812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7CD7167-A07D-6041-AA18-3BB8D6B7DD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8939439"/>
              </p:ext>
            </p:extLst>
          </p:nvPr>
        </p:nvGraphicFramePr>
        <p:xfrm>
          <a:off x="4199831" y="68517"/>
          <a:ext cx="4324737" cy="676353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93832">
                  <a:extLst>
                    <a:ext uri="{9D8B030D-6E8A-4147-A177-3AD203B41FA5}">
                      <a16:colId xmlns:a16="http://schemas.microsoft.com/office/drawing/2014/main" val="3482082889"/>
                    </a:ext>
                  </a:extLst>
                </a:gridCol>
                <a:gridCol w="1061186">
                  <a:extLst>
                    <a:ext uri="{9D8B030D-6E8A-4147-A177-3AD203B41FA5}">
                      <a16:colId xmlns:a16="http://schemas.microsoft.com/office/drawing/2014/main" val="1304374241"/>
                    </a:ext>
                  </a:extLst>
                </a:gridCol>
                <a:gridCol w="928537">
                  <a:extLst>
                    <a:ext uri="{9D8B030D-6E8A-4147-A177-3AD203B41FA5}">
                      <a16:colId xmlns:a16="http://schemas.microsoft.com/office/drawing/2014/main" val="3056800590"/>
                    </a:ext>
                  </a:extLst>
                </a:gridCol>
                <a:gridCol w="1141182">
                  <a:extLst>
                    <a:ext uri="{9D8B030D-6E8A-4147-A177-3AD203B41FA5}">
                      <a16:colId xmlns:a16="http://schemas.microsoft.com/office/drawing/2014/main" val="2001709255"/>
                    </a:ext>
                  </a:extLst>
                </a:gridCol>
              </a:tblGrid>
              <a:tr h="122266"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Table 3 Details of cardiac related events due to Daclizumab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2853349"/>
                  </a:ext>
                </a:extLst>
              </a:tr>
              <a:tr h="23643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Atrial Fibrillation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Cardiac Failur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Coronary Artery Diseas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99213299"/>
                  </a:ext>
                </a:extLst>
              </a:tr>
              <a:tr h="30685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Total number of reported AEs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267189552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Sex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928277828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Female 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50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0 (31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1 (21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341907514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Male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50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0 (62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8 (73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662753066"/>
                  </a:ext>
                </a:extLst>
              </a:tr>
              <a:tr h="15594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t Specified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6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841258520"/>
                  </a:ext>
                </a:extLst>
              </a:tr>
              <a:tr h="15594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Age in years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081755257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18-64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3 (81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4 (7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5 (67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197943686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65-85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18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2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4 (26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021107407"/>
                  </a:ext>
                </a:extLst>
              </a:tr>
              <a:tr h="15594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t Specified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0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3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073090469"/>
                  </a:ext>
                </a:extLst>
              </a:tr>
              <a:tr h="15594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Type of Reaction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909888882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Serious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6 (10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2 (10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1 (98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147647249"/>
                  </a:ext>
                </a:extLst>
              </a:tr>
              <a:tr h="23140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nserious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62229559"/>
                  </a:ext>
                </a:extLst>
              </a:tr>
              <a:tr h="23140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Outcome reported per AE 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645854340"/>
                  </a:ext>
                </a:extLst>
              </a:tr>
              <a:tr h="23140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Hospitalization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12 (37.5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6 (48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0 (44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390128487"/>
                  </a:ext>
                </a:extLst>
              </a:tr>
              <a:tr h="23140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Life-Threatening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9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16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7 (18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431541329"/>
                  </a:ext>
                </a:extLst>
              </a:tr>
              <a:tr h="23140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nserious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0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1 (1.1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141158686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Death 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2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14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1 (12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817227792"/>
                  </a:ext>
                </a:extLst>
              </a:tr>
              <a:tr h="155943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Other Outcome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2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16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16 (17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709109228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Disabled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6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4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141203970"/>
                  </a:ext>
                </a:extLst>
              </a:tr>
              <a:tr h="231402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Congenital Anomaly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0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310345923"/>
                  </a:ext>
                </a:extLst>
              </a:tr>
              <a:tr h="30685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Outcome counts by year received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19249061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1997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664465643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1998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54179480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1999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44473734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0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9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279478926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1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534134334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2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9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025035209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3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3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9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7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506494168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4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6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3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9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92272272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5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9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7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7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272371618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6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6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562147206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7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2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1107997238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8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15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493209506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9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3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9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238099513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0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319178187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2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8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3 (14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400415501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3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4 (15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385835854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4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6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826965006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7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7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4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699477174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8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3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8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484289575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9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2022987252"/>
                  </a:ext>
                </a:extLst>
              </a:tr>
              <a:tr h="122266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20</a:t>
                      </a:r>
                      <a:endParaRPr lang="en-IN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3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0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22" marR="2922" marT="2922" marB="0" anchor="ctr"/>
                </a:tc>
                <a:extLst>
                  <a:ext uri="{0D108BD9-81ED-4DB2-BD59-A6C34878D82A}">
                    <a16:rowId xmlns:a16="http://schemas.microsoft.com/office/drawing/2014/main" val="3244354158"/>
                  </a:ext>
                </a:extLst>
              </a:tr>
            </a:tbl>
          </a:graphicData>
        </a:graphic>
      </p:graphicFrame>
      <p:sp>
        <p:nvSpPr>
          <p:cNvPr id="3" name="TextBox 1">
            <a:extLst>
              <a:ext uri="{FF2B5EF4-FFF2-40B4-BE49-F238E27FC236}">
                <a16:creationId xmlns:a16="http://schemas.microsoft.com/office/drawing/2014/main" id="{14299985-858C-414C-80D5-EEDC223D6AA9}"/>
              </a:ext>
            </a:extLst>
          </p:cNvPr>
          <p:cNvSpPr txBox="1"/>
          <p:nvPr/>
        </p:nvSpPr>
        <p:spPr>
          <a:xfrm>
            <a:off x="153683" y="245496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1.</a:t>
            </a:r>
          </a:p>
        </p:txBody>
      </p:sp>
    </p:spTree>
    <p:extLst>
      <p:ext uri="{BB962C8B-B14F-4D97-AF65-F5344CB8AC3E}">
        <p14:creationId xmlns:p14="http://schemas.microsoft.com/office/powerpoint/2010/main" val="28806926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DA2DEC5-8447-5C4F-80E2-415F4FAC70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8886374"/>
              </p:ext>
            </p:extLst>
          </p:nvPr>
        </p:nvGraphicFramePr>
        <p:xfrm>
          <a:off x="3781778" y="312045"/>
          <a:ext cx="4143021" cy="636640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71400">
                  <a:extLst>
                    <a:ext uri="{9D8B030D-6E8A-4147-A177-3AD203B41FA5}">
                      <a16:colId xmlns:a16="http://schemas.microsoft.com/office/drawing/2014/main" val="75547952"/>
                    </a:ext>
                  </a:extLst>
                </a:gridCol>
                <a:gridCol w="1141888">
                  <a:extLst>
                    <a:ext uri="{9D8B030D-6E8A-4147-A177-3AD203B41FA5}">
                      <a16:colId xmlns:a16="http://schemas.microsoft.com/office/drawing/2014/main" val="918476525"/>
                    </a:ext>
                  </a:extLst>
                </a:gridCol>
                <a:gridCol w="986818">
                  <a:extLst>
                    <a:ext uri="{9D8B030D-6E8A-4147-A177-3AD203B41FA5}">
                      <a16:colId xmlns:a16="http://schemas.microsoft.com/office/drawing/2014/main" val="2474292234"/>
                    </a:ext>
                  </a:extLst>
                </a:gridCol>
                <a:gridCol w="942915">
                  <a:extLst>
                    <a:ext uri="{9D8B030D-6E8A-4147-A177-3AD203B41FA5}">
                      <a16:colId xmlns:a16="http://schemas.microsoft.com/office/drawing/2014/main" val="1328028798"/>
                    </a:ext>
                  </a:extLst>
                </a:gridCol>
              </a:tblGrid>
              <a:tr h="208529"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Table 4 Details of cardiac related events due to Ofatumumab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6316001"/>
                  </a:ext>
                </a:extLst>
              </a:tr>
              <a:tr h="35002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Atrial Fibrillation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Cardiac Failur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Coronary Artery Disease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034745818"/>
                  </a:ext>
                </a:extLst>
              </a:tr>
              <a:tr h="424504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Total number of reported AEs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262602030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Sex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975821240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Female 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0 (23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0 (45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0 (20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220071321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Male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7 (62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40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4 (69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749476597"/>
                  </a:ext>
                </a:extLst>
              </a:tr>
              <a:tr h="215977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t Specified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3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13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10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236991088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Age in years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126260913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18-64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16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18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8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243380308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65-85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2 (51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 (54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6 (73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379234013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&gt; 85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2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4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449833016"/>
                  </a:ext>
                </a:extLst>
              </a:tr>
              <a:tr h="215977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t Specified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13 (30.2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22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9 (18.4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914942631"/>
                  </a:ext>
                </a:extLst>
              </a:tr>
              <a:tr h="215977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Type of Reaction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567674776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Serious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3 (10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2 (10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9 (10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425927258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nserious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798003270"/>
                  </a:ext>
                </a:extLst>
              </a:tr>
              <a:tr h="320240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Outcome reported per AE 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54771609"/>
                  </a:ext>
                </a:extLst>
              </a:tr>
              <a:tr h="320240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Hospitalization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8 (46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3 (35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36 (41.4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179293301"/>
                  </a:ext>
                </a:extLst>
              </a:tr>
              <a:tr h="215977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Life-Threatening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8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5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 (13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902867814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Nonserious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277216939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Death 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5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 (32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10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903891882"/>
                  </a:ext>
                </a:extLst>
              </a:tr>
              <a:tr h="215977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  Other Outcome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4 (40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10 (27.0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 30 (34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708598410"/>
                  </a:ext>
                </a:extLst>
              </a:tr>
              <a:tr h="424504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Outcome counts by year received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 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98243777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8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2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79561625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09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4102477121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0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8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898578631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1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2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952841972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2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8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8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8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794329569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3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8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4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615953357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4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10.8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7 (19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473015028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5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9 (1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5 (13.5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3 (26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694519895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6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6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2 (32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4.6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610812607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7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0 (16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6 (16.2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3.4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1589618312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8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8 (13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3 (8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7 (8.0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4173667910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19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3 (14.9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223564281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20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4 (6.7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1 (1.1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2701712257"/>
                  </a:ext>
                </a:extLst>
              </a:tr>
              <a:tr h="129539">
                <a:tc>
                  <a:txBody>
                    <a:bodyPr/>
                    <a:lstStyle/>
                    <a:p>
                      <a:pPr algn="just" rtl="0" fontAlgn="ctr"/>
                      <a:r>
                        <a:rPr lang="en-IN" sz="800" u="none" strike="noStrike">
                          <a:effectLst/>
                        </a:rPr>
                        <a:t>2021</a:t>
                      </a:r>
                      <a:endParaRPr lang="en-IN" sz="800" b="0" i="0" u="none" strike="noStrike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2 (3.3)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>
                          <a:effectLst/>
                        </a:rPr>
                        <a:t>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IN" sz="800" u="none" strike="noStrike" dirty="0">
                          <a:effectLst/>
                        </a:rPr>
                        <a:t>5 (5.7)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62" marR="3862" marT="3862" marB="0" anchor="ctr"/>
                </a:tc>
                <a:extLst>
                  <a:ext uri="{0D108BD9-81ED-4DB2-BD59-A6C34878D82A}">
                    <a16:rowId xmlns:a16="http://schemas.microsoft.com/office/drawing/2014/main" val="3436205249"/>
                  </a:ext>
                </a:extLst>
              </a:tr>
            </a:tbl>
          </a:graphicData>
        </a:graphic>
      </p:graphicFrame>
      <p:sp>
        <p:nvSpPr>
          <p:cNvPr id="4" name="TextBox 1">
            <a:extLst>
              <a:ext uri="{FF2B5EF4-FFF2-40B4-BE49-F238E27FC236}">
                <a16:creationId xmlns:a16="http://schemas.microsoft.com/office/drawing/2014/main" id="{E54F5022-8707-4B47-A5D1-3497C1C26394}"/>
              </a:ext>
            </a:extLst>
          </p:cNvPr>
          <p:cNvSpPr txBox="1"/>
          <p:nvPr/>
        </p:nvSpPr>
        <p:spPr>
          <a:xfrm>
            <a:off x="694457" y="31204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1.</a:t>
            </a:r>
          </a:p>
        </p:txBody>
      </p:sp>
    </p:spTree>
    <p:extLst>
      <p:ext uri="{BB962C8B-B14F-4D97-AF65-F5344CB8AC3E}">
        <p14:creationId xmlns:p14="http://schemas.microsoft.com/office/powerpoint/2010/main" val="3846564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ontent Placeholder 5">
            <a:extLst>
              <a:ext uri="{FF2B5EF4-FFF2-40B4-BE49-F238E27FC236}">
                <a16:creationId xmlns:a16="http://schemas.microsoft.com/office/drawing/2014/main" id="{9DE80B41-123D-4DAA-817B-95B1EAD6FE9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28018698"/>
              </p:ext>
            </p:extLst>
          </p:nvPr>
        </p:nvGraphicFramePr>
        <p:xfrm>
          <a:off x="2908155" y="1615495"/>
          <a:ext cx="6693045" cy="244987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86697">
                  <a:extLst>
                    <a:ext uri="{9D8B030D-6E8A-4147-A177-3AD203B41FA5}">
                      <a16:colId xmlns:a16="http://schemas.microsoft.com/office/drawing/2014/main" val="3284067184"/>
                    </a:ext>
                  </a:extLst>
                </a:gridCol>
                <a:gridCol w="1246354">
                  <a:extLst>
                    <a:ext uri="{9D8B030D-6E8A-4147-A177-3AD203B41FA5}">
                      <a16:colId xmlns:a16="http://schemas.microsoft.com/office/drawing/2014/main" val="2751594004"/>
                    </a:ext>
                  </a:extLst>
                </a:gridCol>
                <a:gridCol w="1759560">
                  <a:extLst>
                    <a:ext uri="{9D8B030D-6E8A-4147-A177-3AD203B41FA5}">
                      <a16:colId xmlns:a16="http://schemas.microsoft.com/office/drawing/2014/main" val="2012589967"/>
                    </a:ext>
                  </a:extLst>
                </a:gridCol>
                <a:gridCol w="1234135">
                  <a:extLst>
                    <a:ext uri="{9D8B030D-6E8A-4147-A177-3AD203B41FA5}">
                      <a16:colId xmlns:a16="http://schemas.microsoft.com/office/drawing/2014/main" val="803094729"/>
                    </a:ext>
                  </a:extLst>
                </a:gridCol>
                <a:gridCol w="1466299">
                  <a:extLst>
                    <a:ext uri="{9D8B030D-6E8A-4147-A177-3AD203B41FA5}">
                      <a16:colId xmlns:a16="http://schemas.microsoft.com/office/drawing/2014/main" val="1689213480"/>
                    </a:ext>
                  </a:extLst>
                </a:gridCol>
              </a:tblGrid>
              <a:tr h="856781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Drug name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+mn-lt"/>
                          <a:cs typeface="Arial" panose="020B0604020202020204" pitchFamily="34" charset="0"/>
                        </a:rPr>
                        <a:t>Ponesimod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zanimod and ozanimod hydrochloride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Siponimod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ngolimod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2279978"/>
                  </a:ext>
                </a:extLst>
              </a:tr>
              <a:tr h="60647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ll AEs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1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668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3090                        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00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31370618"/>
                  </a:ext>
                </a:extLst>
              </a:tr>
              <a:tr h="3139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HF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0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0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5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8334651"/>
                  </a:ext>
                </a:extLst>
              </a:tr>
              <a:tr h="320141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AF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0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0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50235657"/>
                  </a:ext>
                </a:extLst>
              </a:tr>
              <a:tr h="35257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CAD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0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0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cs typeface="Arial"/>
                        </a:rPr>
                        <a:t>15</a:t>
                      </a:r>
                      <a:endParaRPr lang="en-US" sz="1200" dirty="0">
                        <a:effectLst/>
                        <a:latin typeface="+mn-lt"/>
                        <a:ea typeface="Calibri" panose="020F0502020204030204" pitchFamily="34" charset="0"/>
                        <a:cs typeface="Arial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29597786"/>
                  </a:ext>
                </a:extLst>
              </a:tr>
            </a:tbl>
          </a:graphicData>
        </a:graphic>
      </p:graphicFrame>
      <p:sp>
        <p:nvSpPr>
          <p:cNvPr id="4" name="TextBox 1">
            <a:extLst>
              <a:ext uri="{FF2B5EF4-FFF2-40B4-BE49-F238E27FC236}">
                <a16:creationId xmlns:a16="http://schemas.microsoft.com/office/drawing/2014/main" id="{4C033D13-7D6D-4054-9627-BFCE15183AC0}"/>
              </a:ext>
            </a:extLst>
          </p:cNvPr>
          <p:cNvSpPr txBox="1"/>
          <p:nvPr/>
        </p:nvSpPr>
        <p:spPr>
          <a:xfrm>
            <a:off x="4902664" y="707612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4.</a:t>
            </a:r>
          </a:p>
        </p:txBody>
      </p:sp>
    </p:spTree>
    <p:extLst>
      <p:ext uri="{BB962C8B-B14F-4D97-AF65-F5344CB8AC3E}">
        <p14:creationId xmlns:p14="http://schemas.microsoft.com/office/powerpoint/2010/main" val="3434437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260</Words>
  <Application>Microsoft Office PowerPoint</Application>
  <PresentationFormat>Widescreen</PresentationFormat>
  <Paragraphs>46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 1</dc:title>
  <dc:creator>Al Yafeai, Zaki</dc:creator>
  <cp:lastModifiedBy>Al Yafeai, Zaki</cp:lastModifiedBy>
  <cp:revision>5</cp:revision>
  <dcterms:created xsi:type="dcterms:W3CDTF">2021-11-16T19:19:35Z</dcterms:created>
  <dcterms:modified xsi:type="dcterms:W3CDTF">2021-12-11T23:48:19Z</dcterms:modified>
</cp:coreProperties>
</file>